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3B5C5E06-6893-4B12-9097-FEA05BDF2EB0}">
          <p14:sldIdLst>
            <p14:sldId id="27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3C2BD85-0916-1389-BFDE-97929589B592}" name="Hibi Masanobu (日比 壮信)" initials="HM(壮" userId="S::317134@kao.com::7ecd3eeb-9a65-439a-98e1-fbb44e465c4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00" autoAdjust="0"/>
    <p:restoredTop sz="93196" autoAdjust="0"/>
  </p:normalViewPr>
  <p:slideViewPr>
    <p:cSldViewPr snapToGrid="0">
      <p:cViewPr varScale="1">
        <p:scale>
          <a:sx n="72" d="100"/>
          <a:sy n="72" d="100"/>
        </p:scale>
        <p:origin x="313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A08401-40C0-4533-88CA-6BF2D674954F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D0152C-C251-42B8-8E8F-78578B54AD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0857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778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73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8512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2390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106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016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217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920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347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3782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8556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FBC432-90C2-4A0F-8372-9D048EF1C3EA}" type="datetimeFigureOut">
              <a:rPr kumimoji="1" lang="ja-JP" altLang="en-US" smtClean="0"/>
              <a:t>2025/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C878CC-58B0-450F-A19B-9B18D417D5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4649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グラフ&#10;&#10;自動的に生成された説明">
            <a:extLst>
              <a:ext uri="{FF2B5EF4-FFF2-40B4-BE49-F238E27FC236}">
                <a16:creationId xmlns:a16="http://schemas.microsoft.com/office/drawing/2014/main" id="{7FC18022-E461-CB0E-B8F1-ACA20F0D117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93" t="11816" b="6337"/>
          <a:stretch/>
        </p:blipFill>
        <p:spPr>
          <a:xfrm>
            <a:off x="1450362" y="4345303"/>
            <a:ext cx="2282060" cy="1215393"/>
          </a:xfrm>
          <a:prstGeom prst="rect">
            <a:avLst/>
          </a:prstGeom>
        </p:spPr>
      </p:pic>
      <p:pic>
        <p:nvPicPr>
          <p:cNvPr id="3" name="図 2" descr="グラフ&#10;&#10;自動的に生成された説明">
            <a:extLst>
              <a:ext uri="{FF2B5EF4-FFF2-40B4-BE49-F238E27FC236}">
                <a16:creationId xmlns:a16="http://schemas.microsoft.com/office/drawing/2014/main" id="{5D186E27-4855-2C75-F7DF-7840CA11465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23" t="12691" b="5385"/>
          <a:stretch/>
        </p:blipFill>
        <p:spPr>
          <a:xfrm>
            <a:off x="3653350" y="4374979"/>
            <a:ext cx="2264356" cy="1215393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BF835313-74DF-FEFD-2C2C-CB5E07D82E22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3811155" y="4331275"/>
            <a:ext cx="547837" cy="14403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17D5522D-936C-6568-8BBB-88ECD562A9E2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4484117" y="4672039"/>
            <a:ext cx="547837" cy="14403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72CC9BEA-D4BD-4DDF-726E-7F5D589485A5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5145191" y="4338230"/>
            <a:ext cx="547837" cy="144030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EEF4A77-2082-8D22-471F-0245490E738F}"/>
              </a:ext>
            </a:extLst>
          </p:cNvPr>
          <p:cNvSpPr txBox="1"/>
          <p:nvPr/>
        </p:nvSpPr>
        <p:spPr>
          <a:xfrm>
            <a:off x="3736628" y="4171830"/>
            <a:ext cx="593879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91" b="1" dirty="0">
                <a:latin typeface="Arial" panose="020B0604020202020204" pitchFamily="34" charset="0"/>
                <a:cs typeface="Arial" panose="020B0604020202020204" pitchFamily="34" charset="0"/>
              </a:rPr>
              <a:t>p = 0.351 </a:t>
            </a:r>
            <a:endParaRPr lang="ja-JP" altLang="en-US" sz="59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330BDF0-346B-06B9-E552-9F5E01783FEC}"/>
              </a:ext>
            </a:extLst>
          </p:cNvPr>
          <p:cNvSpPr txBox="1"/>
          <p:nvPr/>
        </p:nvSpPr>
        <p:spPr>
          <a:xfrm>
            <a:off x="4409248" y="4487177"/>
            <a:ext cx="593879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91" b="1" dirty="0">
                <a:latin typeface="Arial" panose="020B0604020202020204" pitchFamily="34" charset="0"/>
                <a:cs typeface="Arial" panose="020B0604020202020204" pitchFamily="34" charset="0"/>
              </a:rPr>
              <a:t>p = 0.930 </a:t>
            </a:r>
            <a:endParaRPr lang="ja-JP" altLang="en-US" sz="59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F972880-39A0-C533-8650-F10092475AB6}"/>
              </a:ext>
            </a:extLst>
          </p:cNvPr>
          <p:cNvSpPr txBox="1"/>
          <p:nvPr/>
        </p:nvSpPr>
        <p:spPr>
          <a:xfrm>
            <a:off x="5076128" y="4171246"/>
            <a:ext cx="593879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91" b="1" dirty="0">
                <a:latin typeface="Arial" panose="020B0604020202020204" pitchFamily="34" charset="0"/>
                <a:cs typeface="Arial" panose="020B0604020202020204" pitchFamily="34" charset="0"/>
              </a:rPr>
              <a:t>p = 0.205 </a:t>
            </a:r>
            <a:endParaRPr lang="ja-JP" altLang="en-US" sz="59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7AB374B-B7AE-FE78-AFEB-3EB6E933A3AD}"/>
              </a:ext>
            </a:extLst>
          </p:cNvPr>
          <p:cNvSpPr txBox="1"/>
          <p:nvPr/>
        </p:nvSpPr>
        <p:spPr>
          <a:xfrm>
            <a:off x="4085073" y="3962750"/>
            <a:ext cx="12875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900" b="1" dirty="0"/>
              <a:t>Ser(D%) </a:t>
            </a:r>
            <a:r>
              <a:rPr lang="en-US" altLang="ja-JP" sz="675" b="1" dirty="0"/>
              <a:t>MCI : MMSE</a:t>
            </a:r>
            <a:r>
              <a:rPr lang="en-US" altLang="ja-JP" sz="619" b="1" dirty="0"/>
              <a:t> </a:t>
            </a:r>
            <a:r>
              <a:rPr lang="ja-JP" altLang="en-US" sz="619" b="1" dirty="0"/>
              <a:t>≦</a:t>
            </a:r>
            <a:r>
              <a:rPr lang="en-US" altLang="ja-JP" sz="619" b="1" dirty="0"/>
              <a:t> 27</a:t>
            </a:r>
            <a:endParaRPr lang="ja-JP" altLang="en-US" sz="900" b="1" dirty="0"/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BA8F8762-10CA-C609-D134-40BBCC3F02AE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619540" y="4302421"/>
            <a:ext cx="547837" cy="14403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D703449E-5F51-8F8A-32AC-B5833D1FD636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2281129" y="4655429"/>
            <a:ext cx="547837" cy="14403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D5699E26-CA9A-115F-CEB6-3704BCC60F13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2942437" y="4316992"/>
            <a:ext cx="547837" cy="14403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2053A8C-4FBE-4677-C313-E9C9A5AE7963}"/>
              </a:ext>
            </a:extLst>
          </p:cNvPr>
          <p:cNvSpPr txBox="1"/>
          <p:nvPr/>
        </p:nvSpPr>
        <p:spPr>
          <a:xfrm>
            <a:off x="1556091" y="4140607"/>
            <a:ext cx="593879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91" b="1" dirty="0">
                <a:latin typeface="Arial" panose="020B0604020202020204" pitchFamily="34" charset="0"/>
                <a:cs typeface="Arial" panose="020B0604020202020204" pitchFamily="34" charset="0"/>
              </a:rPr>
              <a:t>p = 0.340 </a:t>
            </a:r>
            <a:endParaRPr lang="ja-JP" altLang="en-US" sz="59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215C2FD-336D-5BA1-B0D9-E6538011B1F8}"/>
              </a:ext>
            </a:extLst>
          </p:cNvPr>
          <p:cNvSpPr txBox="1"/>
          <p:nvPr/>
        </p:nvSpPr>
        <p:spPr>
          <a:xfrm>
            <a:off x="2222267" y="4489333"/>
            <a:ext cx="593879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91" b="1" dirty="0">
                <a:latin typeface="Arial" panose="020B0604020202020204" pitchFamily="34" charset="0"/>
                <a:cs typeface="Arial" panose="020B0604020202020204" pitchFamily="34" charset="0"/>
              </a:rPr>
              <a:t>p = 0.973 </a:t>
            </a:r>
            <a:endParaRPr lang="ja-JP" altLang="en-US" sz="59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AE0535C-0113-DA56-9A61-4029A96655CE}"/>
              </a:ext>
            </a:extLst>
          </p:cNvPr>
          <p:cNvSpPr txBox="1"/>
          <p:nvPr/>
        </p:nvSpPr>
        <p:spPr>
          <a:xfrm>
            <a:off x="2879325" y="4140607"/>
            <a:ext cx="593879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91" b="1" dirty="0">
                <a:latin typeface="Arial" panose="020B0604020202020204" pitchFamily="34" charset="0"/>
                <a:cs typeface="Arial" panose="020B0604020202020204" pitchFamily="34" charset="0"/>
              </a:rPr>
              <a:t>p = 0.139 </a:t>
            </a:r>
            <a:endParaRPr lang="ja-JP" altLang="en-US" sz="59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F574411-E479-CC46-1FD2-BF5F3830AC45}"/>
              </a:ext>
            </a:extLst>
          </p:cNvPr>
          <p:cNvSpPr txBox="1"/>
          <p:nvPr/>
        </p:nvSpPr>
        <p:spPr>
          <a:xfrm>
            <a:off x="1847841" y="3959289"/>
            <a:ext cx="12875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900" b="1" dirty="0"/>
              <a:t>Ser(D%) </a:t>
            </a:r>
            <a:r>
              <a:rPr lang="en-US" altLang="ja-JP" sz="675" b="1" dirty="0"/>
              <a:t>MCI : MMSE</a:t>
            </a:r>
            <a:r>
              <a:rPr lang="en-US" altLang="ja-JP" sz="619" b="1" dirty="0"/>
              <a:t> </a:t>
            </a:r>
            <a:r>
              <a:rPr lang="ja-JP" altLang="en-US" sz="619" b="1" dirty="0"/>
              <a:t>≦</a:t>
            </a:r>
            <a:r>
              <a:rPr lang="en-US" altLang="ja-JP" sz="619" b="1" dirty="0"/>
              <a:t> 26</a:t>
            </a:r>
            <a:endParaRPr lang="ja-JP" altLang="en-US" sz="900" b="1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2428CFC-B6A5-D416-89E1-5966695FC9A2}"/>
              </a:ext>
            </a:extLst>
          </p:cNvPr>
          <p:cNvSpPr txBox="1"/>
          <p:nvPr/>
        </p:nvSpPr>
        <p:spPr>
          <a:xfrm>
            <a:off x="3820189" y="5616582"/>
            <a:ext cx="406337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/>
              <a:t>all</a:t>
            </a:r>
            <a:endParaRPr lang="ja-JP" altLang="en-US" sz="788" b="1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1E6D396-2ABF-31B9-10F1-D23E804E6138}"/>
              </a:ext>
            </a:extLst>
          </p:cNvPr>
          <p:cNvSpPr txBox="1"/>
          <p:nvPr/>
        </p:nvSpPr>
        <p:spPr>
          <a:xfrm>
            <a:off x="4358952" y="5616582"/>
            <a:ext cx="655241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/>
              <a:t>male</a:t>
            </a:r>
            <a:endParaRPr lang="ja-JP" altLang="en-US" sz="788" b="1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6AE5CF3-0E9B-BDB9-26F7-55DACAD74734}"/>
              </a:ext>
            </a:extLst>
          </p:cNvPr>
          <p:cNvSpPr txBox="1"/>
          <p:nvPr/>
        </p:nvSpPr>
        <p:spPr>
          <a:xfrm>
            <a:off x="5067731" y="5616582"/>
            <a:ext cx="72159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/>
              <a:t>female</a:t>
            </a:r>
            <a:endParaRPr lang="ja-JP" altLang="en-US" sz="788" b="1" dirty="0"/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426CFDA5-9470-A5D7-B260-6BEAA9EF27B3}"/>
              </a:ext>
            </a:extLst>
          </p:cNvPr>
          <p:cNvCxnSpPr>
            <a:cxnSpLocks/>
          </p:cNvCxnSpPr>
          <p:nvPr/>
        </p:nvCxnSpPr>
        <p:spPr>
          <a:xfrm>
            <a:off x="3820189" y="5605413"/>
            <a:ext cx="44748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C5BB71F3-12C6-ECCF-E79D-6C3A2F32AD6D}"/>
              </a:ext>
            </a:extLst>
          </p:cNvPr>
          <p:cNvCxnSpPr>
            <a:cxnSpLocks/>
          </p:cNvCxnSpPr>
          <p:nvPr/>
        </p:nvCxnSpPr>
        <p:spPr>
          <a:xfrm>
            <a:off x="4487871" y="5607500"/>
            <a:ext cx="44748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CAFECBCC-0899-19C8-6199-97F36765F501}"/>
              </a:ext>
            </a:extLst>
          </p:cNvPr>
          <p:cNvCxnSpPr>
            <a:cxnSpLocks/>
          </p:cNvCxnSpPr>
          <p:nvPr/>
        </p:nvCxnSpPr>
        <p:spPr>
          <a:xfrm>
            <a:off x="5176578" y="5604331"/>
            <a:ext cx="44748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A784A5E-F907-6BDD-BBD6-F4F0C5C9BE01}"/>
              </a:ext>
            </a:extLst>
          </p:cNvPr>
          <p:cNvSpPr txBox="1"/>
          <p:nvPr/>
        </p:nvSpPr>
        <p:spPr>
          <a:xfrm>
            <a:off x="1631783" y="5620937"/>
            <a:ext cx="406337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/>
              <a:t>all</a:t>
            </a:r>
            <a:endParaRPr lang="ja-JP" altLang="en-US" sz="788" b="1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BF4C44F-E6ED-5CFB-0949-91FCC031EED1}"/>
              </a:ext>
            </a:extLst>
          </p:cNvPr>
          <p:cNvSpPr txBox="1"/>
          <p:nvPr/>
        </p:nvSpPr>
        <p:spPr>
          <a:xfrm>
            <a:off x="2170546" y="5620937"/>
            <a:ext cx="655241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/>
              <a:t>male</a:t>
            </a:r>
            <a:endParaRPr lang="ja-JP" altLang="en-US" sz="788" b="1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C4581E3-2B82-FB96-DAE0-0D25A02AD78D}"/>
              </a:ext>
            </a:extLst>
          </p:cNvPr>
          <p:cNvSpPr txBox="1"/>
          <p:nvPr/>
        </p:nvSpPr>
        <p:spPr>
          <a:xfrm>
            <a:off x="2879325" y="5620937"/>
            <a:ext cx="721595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/>
              <a:t>female</a:t>
            </a:r>
            <a:endParaRPr lang="ja-JP" altLang="en-US" sz="788" b="1" dirty="0"/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3E0337A6-0D1B-EE17-D409-2A086C8A5637}"/>
              </a:ext>
            </a:extLst>
          </p:cNvPr>
          <p:cNvCxnSpPr>
            <a:cxnSpLocks/>
          </p:cNvCxnSpPr>
          <p:nvPr/>
        </p:nvCxnSpPr>
        <p:spPr>
          <a:xfrm>
            <a:off x="1631783" y="5609768"/>
            <a:ext cx="44748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99866EB7-7610-B628-77D0-378BBB8DE75B}"/>
              </a:ext>
            </a:extLst>
          </p:cNvPr>
          <p:cNvCxnSpPr>
            <a:cxnSpLocks/>
          </p:cNvCxnSpPr>
          <p:nvPr/>
        </p:nvCxnSpPr>
        <p:spPr>
          <a:xfrm>
            <a:off x="2299465" y="5611855"/>
            <a:ext cx="44748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D0C7E176-BCF7-662A-9636-0D86BC7EA40F}"/>
              </a:ext>
            </a:extLst>
          </p:cNvPr>
          <p:cNvCxnSpPr>
            <a:cxnSpLocks/>
          </p:cNvCxnSpPr>
          <p:nvPr/>
        </p:nvCxnSpPr>
        <p:spPr>
          <a:xfrm>
            <a:off x="2988172" y="5608686"/>
            <a:ext cx="44748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FEA483BB-AB2B-EE53-3AF4-CD26D07F25E3}"/>
              </a:ext>
            </a:extLst>
          </p:cNvPr>
          <p:cNvSpPr txBox="1"/>
          <p:nvPr/>
        </p:nvSpPr>
        <p:spPr>
          <a:xfrm rot="16200000">
            <a:off x="649192" y="4776800"/>
            <a:ext cx="1300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b="1" dirty="0"/>
              <a:t>Enantiomeric ratio in whole fingertip blood (D%)</a:t>
            </a:r>
            <a:endParaRPr lang="ja-JP" altLang="en-US" sz="700" b="1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83801CF-2DEB-A5FB-AD04-B6A99268E9F6}"/>
              </a:ext>
            </a:extLst>
          </p:cNvPr>
          <p:cNvSpPr txBox="1"/>
          <p:nvPr/>
        </p:nvSpPr>
        <p:spPr>
          <a:xfrm>
            <a:off x="0" y="0"/>
            <a:ext cx="1730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56084"/>
            <a:r>
              <a:rPr lang="en-US" altLang="ja-JP" sz="1200" dirty="0">
                <a:solidFill>
                  <a:prstClr val="black"/>
                </a:solidFill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3820281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5</TotalTime>
  <Words>54</Words>
  <Application>Microsoft Office PowerPoint</Application>
  <PresentationFormat>A4 210 x 297 mm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ptos</vt:lpstr>
      <vt:lpstr>Aptos Display</vt:lpstr>
      <vt:lpstr>Arial</vt:lpstr>
      <vt:lpstr>Cambri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giki So (杉木 創)</dc:creator>
  <cp:lastModifiedBy>Sugiki So (杉木 創)</cp:lastModifiedBy>
  <cp:revision>27</cp:revision>
  <dcterms:created xsi:type="dcterms:W3CDTF">2024-05-29T02:05:01Z</dcterms:created>
  <dcterms:modified xsi:type="dcterms:W3CDTF">2025-02-06T01:26:28Z</dcterms:modified>
</cp:coreProperties>
</file>